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oup 234">
            <a:extLst>
              <a:ext uri="{FF2B5EF4-FFF2-40B4-BE49-F238E27FC236}">
                <a16:creationId xmlns:a16="http://schemas.microsoft.com/office/drawing/2014/main" id="{114FB08E-9664-4C8A-8FE8-E5EB6C1C6A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927141"/>
              </p:ext>
            </p:extLst>
          </p:nvPr>
        </p:nvGraphicFramePr>
        <p:xfrm>
          <a:off x="360329" y="595932"/>
          <a:ext cx="7105341" cy="6212133"/>
        </p:xfrm>
        <a:graphic>
          <a:graphicData uri="http://schemas.openxmlformats.org/drawingml/2006/table">
            <a:tbl>
              <a:tblPr/>
              <a:tblGrid>
                <a:gridCol w="17124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504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277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524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642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421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939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2962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7679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9641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eason's  Product-moment correlatio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pearman's rank difference correlatio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1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2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ｒ</a:t>
                      </a:r>
                      <a:endParaRPr kumimoji="1" lang="ja-JP" altLang="en-US" sz="17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ρ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7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1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0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8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3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701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0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5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4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9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1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0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1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2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3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7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5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9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3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0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8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0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4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9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2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3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2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549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3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7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 (days)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8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4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1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8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4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0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9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7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549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2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2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0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6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245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3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9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0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3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1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6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0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397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4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2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3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5041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2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821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8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1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7600" marR="87600" marT="43808" marB="4380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A2CA2ED-AB00-44CA-AC07-AC17AF6C7BC5}"/>
              </a:ext>
            </a:extLst>
          </p:cNvPr>
          <p:cNvSpPr txBox="1"/>
          <p:nvPr/>
        </p:nvSpPr>
        <p:spPr>
          <a:xfrm>
            <a:off x="301801" y="12962"/>
            <a:ext cx="6403869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Correlation between serum sCD26/DPP4 titer variation (%) and tumor volume </a:t>
            </a:r>
          </a:p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 or PFS (days) in 18 cases with Q2W administration by PPMC or SRDC analysis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410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7</TotalTime>
  <Words>320</Words>
  <Application>Microsoft Office PowerPoint</Application>
  <PresentationFormat>画面に合わせる (4:3)</PresentationFormat>
  <Paragraphs>19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6:16Z</dcterms:modified>
</cp:coreProperties>
</file>